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315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477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176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389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97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34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020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230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956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31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519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567E49-94D6-4081-AE62-D488C5CB971D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D1192-2368-41EC-B2E1-792430786D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267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DFD60A71-B539-A546-B6D6-22D7B0E574C8}"/>
              </a:ext>
            </a:extLst>
          </p:cNvPr>
          <p:cNvSpPr/>
          <p:nvPr/>
        </p:nvSpPr>
        <p:spPr>
          <a:xfrm>
            <a:off x="456232" y="628456"/>
            <a:ext cx="17491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le 2</a:t>
            </a:r>
            <a:endParaRPr lang="fr-FR" dirty="0"/>
          </a:p>
        </p:txBody>
      </p:sp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xmlns="" id="{8DEEE375-E529-8A47-96DD-969974C9D70F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473903" y="2282006"/>
          <a:ext cx="8778398" cy="206421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0617">
                  <a:extLst>
                    <a:ext uri="{9D8B030D-6E8A-4147-A177-3AD203B41FA5}">
                      <a16:colId xmlns:a16="http://schemas.microsoft.com/office/drawing/2014/main" xmlns="" val="2570659407"/>
                    </a:ext>
                  </a:extLst>
                </a:gridCol>
                <a:gridCol w="69850">
                  <a:extLst>
                    <a:ext uri="{9D8B030D-6E8A-4147-A177-3AD203B41FA5}">
                      <a16:colId xmlns:a16="http://schemas.microsoft.com/office/drawing/2014/main" xmlns="" val="3989182542"/>
                    </a:ext>
                  </a:extLst>
                </a:gridCol>
                <a:gridCol w="3977111">
                  <a:extLst>
                    <a:ext uri="{9D8B030D-6E8A-4147-A177-3AD203B41FA5}">
                      <a16:colId xmlns:a16="http://schemas.microsoft.com/office/drawing/2014/main" xmlns="" val="2798203072"/>
                    </a:ext>
                  </a:extLst>
                </a:gridCol>
                <a:gridCol w="1564413">
                  <a:extLst>
                    <a:ext uri="{9D8B030D-6E8A-4147-A177-3AD203B41FA5}">
                      <a16:colId xmlns:a16="http://schemas.microsoft.com/office/drawing/2014/main" xmlns="" val="3240982414"/>
                    </a:ext>
                  </a:extLst>
                </a:gridCol>
                <a:gridCol w="2218869">
                  <a:extLst>
                    <a:ext uri="{9D8B030D-6E8A-4147-A177-3AD203B41FA5}">
                      <a16:colId xmlns:a16="http://schemas.microsoft.com/office/drawing/2014/main" xmlns="" val="2232989923"/>
                    </a:ext>
                  </a:extLst>
                </a:gridCol>
                <a:gridCol w="777538">
                  <a:extLst>
                    <a:ext uri="{9D8B030D-6E8A-4147-A177-3AD203B41FA5}">
                      <a16:colId xmlns:a16="http://schemas.microsoft.com/office/drawing/2014/main" xmlns="" val="1943314608"/>
                    </a:ext>
                  </a:extLst>
                </a:gridCol>
              </a:tblGrid>
              <a:tr h="253654">
                <a:tc>
                  <a:txBody>
                    <a:bodyPr/>
                    <a:lstStyle/>
                    <a:p>
                      <a:pPr algn="l"/>
                      <a:endParaRPr lang="fr-FR" sz="12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fr-FR" sz="12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fr-FR" sz="12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lang="fr-FR" sz="12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06717118"/>
                  </a:ext>
                </a:extLst>
              </a:tr>
              <a:tr h="288640">
                <a:tc grid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Induction drugs</a:t>
                      </a:r>
                      <a:endParaRPr lang="fr-FR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fr-FR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ysClr val="windowText" lastClr="000000"/>
                          </a:solidFill>
                          <a:effectLst/>
                        </a:rPr>
                        <a:t>No PIHI (n = 69)</a:t>
                      </a:r>
                      <a:endParaRPr lang="fr-FR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solidFill>
                            <a:sysClr val="windowText" lastClr="000000"/>
                          </a:solidFill>
                          <a:effectLst/>
                        </a:rPr>
                        <a:t>PIHI (n = 51)</a:t>
                      </a:r>
                      <a:endParaRPr lang="fr-FR" sz="12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solidFill>
                            <a:sysClr val="windowText" lastClr="000000"/>
                          </a:solidFill>
                          <a:effectLst/>
                        </a:rPr>
                        <a:t>P value</a:t>
                      </a:r>
                      <a:endParaRPr lang="fr-FR" sz="12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18511567"/>
                  </a:ext>
                </a:extLst>
              </a:tr>
              <a:tr h="253654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Etomidat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Etomidat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60 (87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46 (90) 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0.58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23607529"/>
                  </a:ext>
                </a:extLst>
              </a:tr>
              <a:tr h="253654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Ketamin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Ketamine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1 (1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4 (8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0.08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519433"/>
                  </a:ext>
                </a:extLst>
              </a:tr>
              <a:tr h="253654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ropofol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ropofol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8 (12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1 (2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0.0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66121623"/>
                  </a:ext>
                </a:extLst>
              </a:tr>
              <a:tr h="253654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</a:rPr>
                        <a:t>Suxamethonium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uxamethonium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33 (55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6 (14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&lt;0.00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94253638"/>
                  </a:ext>
                </a:extLst>
              </a:tr>
              <a:tr h="253654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ocuronium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ocuronium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19 (32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14 (32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0.99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42991247"/>
                  </a:ext>
                </a:extLst>
              </a:tr>
              <a:tr h="253654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fr-FR" sz="1200">
                          <a:effectLst/>
                        </a:rPr>
                        <a:t> 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tracuriu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tracurium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2 (3)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1(7)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200" dirty="0">
                          <a:effectLst/>
                        </a:rPr>
                        <a:t>0.74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24514230"/>
                  </a:ext>
                </a:extLst>
              </a:tr>
            </a:tbl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C54C71B2-6DE3-3740-AFD8-F670B46A629D}"/>
              </a:ext>
            </a:extLst>
          </p:cNvPr>
          <p:cNvSpPr txBox="1"/>
          <p:nvPr/>
        </p:nvSpPr>
        <p:spPr>
          <a:xfrm>
            <a:off x="699911" y="5630442"/>
            <a:ext cx="107244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 </a:t>
            </a:r>
            <a:endParaRPr lang="fr-FR" sz="1400" b="1" dirty="0"/>
          </a:p>
          <a:p>
            <a:r>
              <a:rPr lang="en-US" sz="1400" b="1" dirty="0"/>
              <a:t>Additional file 2. </a:t>
            </a:r>
            <a:r>
              <a:rPr lang="en-US" sz="1400" dirty="0"/>
              <a:t>Induction drugs used for patients who developed post-intubation hemodynamic instability (PIHI) or not (No PIHI)</a:t>
            </a:r>
            <a:endParaRPr lang="fr-FR" sz="1400" dirty="0"/>
          </a:p>
          <a:p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280894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M.</dc:creator>
  <cp:lastModifiedBy>Saranya M.</cp:lastModifiedBy>
  <cp:revision>1</cp:revision>
  <dcterms:created xsi:type="dcterms:W3CDTF">2022-07-04T08:56:02Z</dcterms:created>
  <dcterms:modified xsi:type="dcterms:W3CDTF">2022-07-04T08:56:09Z</dcterms:modified>
</cp:coreProperties>
</file>